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bin" ContentType="application/vnd.openxmlformats-officedocument.oleObject"/>
  <Override PartName="/ppt/media/image1.wmf" ContentType="image/x-wmf"/>
  <Override PartName="/ppt/media/image2.png" ContentType="image/png"/>
  <Override PartName="/ppt/media/image3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670675" cy="9928225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CB3B09-A027-4676-BF0D-0274487D521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4A38B8-F5AB-426C-9D6D-F4A7FCFABF6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2D13F4-A086-4BA6-A4A3-FE615F5EBAE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B8A5DD-0654-424D-B87A-7BDA1AA26A4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B4C3B3-7C6E-4429-A0C9-DB0F1583AB1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919521-991A-4BBF-A9DE-4AFF9D3FF9E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DD223C-AFF0-4E9E-B44A-7A66BA11CDB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FD5AA7-F0D1-4C51-A2CA-3956550299E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B27C22-38C4-429A-B599-36379DA493C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E5EFC6-7B49-4230-98A2-37540FDD024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B63FEF-A54A-4B4B-8BED-03C67B4D9F4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183194-CE91-48D9-9498-3A999E72186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TW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TW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2160"/>
            <a:ext cx="217152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TW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5AD62E8-1E0C-4039-948C-B09F58F0FBE4}" type="slidenum">
              <a:rPr b="0" lang="zh-TW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wmf"/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3"/>
          <p:cNvGrpSpPr/>
          <p:nvPr/>
        </p:nvGrpSpPr>
        <p:grpSpPr>
          <a:xfrm>
            <a:off x="1044720" y="762120"/>
            <a:ext cx="4552920" cy="1954440"/>
            <a:chOff x="1044720" y="762120"/>
            <a:chExt cx="4552920" cy="1954440"/>
          </a:xfrm>
        </p:grpSpPr>
        <p:graphicFrame>
          <p:nvGraphicFramePr>
            <p:cNvPr id="42" name="Object 6"/>
            <p:cNvGraphicFramePr/>
            <p:nvPr/>
          </p:nvGraphicFramePr>
          <p:xfrm>
            <a:off x="1207800" y="762120"/>
            <a:ext cx="1762200" cy="1800000"/>
          </p:xfrm>
          <a:graphic>
            <a:graphicData uri="http://schemas.openxmlformats.org/presentationml/2006/ole">
              <p:oleObj r:id="rId1" spid="">
                <p:embed/>
                <p:pic>
                  <p:nvPicPr>
                    <p:cNvPr id="43" name="Object 6" descr=""/>
                    <p:cNvPicPr/>
                    <p:nvPr/>
                  </p:nvPicPr>
                  <p:blipFill>
                    <a:blip r:embed="rId2"/>
                    <a:stretch/>
                  </p:blipFill>
                  <p:spPr>
                    <a:xfrm>
                      <a:off x="1207800" y="762120"/>
                      <a:ext cx="1762200" cy="180000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44" name="TextBox 28"/>
            <p:cNvSpPr/>
            <p:nvPr/>
          </p:nvSpPr>
          <p:spPr>
            <a:xfrm rot="16200000">
              <a:off x="424440" y="1587600"/>
              <a:ext cx="150192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Relative </a:t>
              </a:r>
              <a:r>
                <a:rPr b="1" i="1" lang="en-US" sz="11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miR-26a</a:t>
              </a:r>
              <a:r>
                <a:rPr b="1" lang="en-US" sz="11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level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TextBox 31"/>
            <p:cNvSpPr/>
            <p:nvPr/>
          </p:nvSpPr>
          <p:spPr>
            <a:xfrm>
              <a:off x="1575000" y="2470320"/>
              <a:ext cx="1297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Control          miR-26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46" name="Picture 2" descr=""/>
            <p:cNvPicPr/>
            <p:nvPr/>
          </p:nvPicPr>
          <p:blipFill>
            <a:blip r:embed="rId3"/>
            <a:srcRect l="0" t="0" r="66945" b="0"/>
            <a:stretch/>
          </p:blipFill>
          <p:spPr>
            <a:xfrm>
              <a:off x="4229280" y="1306440"/>
              <a:ext cx="1368360" cy="43164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47" name="Picture 4" descr=""/>
            <p:cNvPicPr/>
            <p:nvPr/>
          </p:nvPicPr>
          <p:blipFill>
            <a:blip r:embed="rId4"/>
            <a:srcRect l="0" t="0" r="67290" b="0"/>
            <a:stretch/>
          </p:blipFill>
          <p:spPr>
            <a:xfrm>
              <a:off x="4229280" y="1739880"/>
              <a:ext cx="1368360" cy="43164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sp>
          <p:nvSpPr>
            <p:cNvPr id="48" name="TextBox 74"/>
            <p:cNvSpPr/>
            <p:nvPr/>
          </p:nvSpPr>
          <p:spPr>
            <a:xfrm>
              <a:off x="3484440" y="1401840"/>
              <a:ext cx="7365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EZH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TextBox 75"/>
            <p:cNvSpPr/>
            <p:nvPr/>
          </p:nvSpPr>
          <p:spPr>
            <a:xfrm>
              <a:off x="3435120" y="1797120"/>
              <a:ext cx="863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l-GR" sz="12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β</a:t>
              </a:r>
              <a:r>
                <a:rPr b="1" lang="en-US" sz="12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-acti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TextBox 41"/>
            <p:cNvSpPr/>
            <p:nvPr/>
          </p:nvSpPr>
          <p:spPr>
            <a:xfrm>
              <a:off x="4214160" y="1047600"/>
              <a:ext cx="1326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 </a:t>
              </a:r>
              <a:r>
                <a:rPr b="1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Control         miR-26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TextBox 75"/>
            <p:cNvSpPr/>
            <p:nvPr/>
          </p:nvSpPr>
          <p:spPr>
            <a:xfrm>
              <a:off x="3290760" y="2173320"/>
              <a:ext cx="11462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Relative signal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(EZH2/</a:t>
              </a:r>
              <a:r>
                <a:rPr b="1" lang="el-GR" sz="9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β</a:t>
              </a:r>
              <a:r>
                <a:rPr b="1" lang="en-US" sz="9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-actin) 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TextBox 43"/>
            <p:cNvSpPr/>
            <p:nvPr/>
          </p:nvSpPr>
          <p:spPr>
            <a:xfrm>
              <a:off x="4465800" y="2211480"/>
              <a:ext cx="9716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1            0.6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3" name="TextBox 12"/>
          <p:cNvSpPr/>
          <p:nvPr/>
        </p:nvSpPr>
        <p:spPr>
          <a:xfrm>
            <a:off x="662040" y="2922480"/>
            <a:ext cx="5573520" cy="1736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3.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ffect of ectopic miR-26a over-expression on EZH2 expression in PLC5 HBV-associated HCC cell line. (A) </a:t>
            </a:r>
            <a:r>
              <a:rPr b="0" lang="zh-TW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iR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26a</a:t>
            </a:r>
            <a:r>
              <a:rPr b="0" lang="zh-TW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expression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upon Lipofectamine 2000-mediated transfection of mimics </a:t>
            </a:r>
            <a:r>
              <a:rPr b="0" lang="zh-TW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was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easured </a:t>
            </a:r>
            <a:r>
              <a:rPr b="0" lang="zh-TW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y quantitative PCR using miScript Reverse Transcription and miScript SYBR Green PCR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.</a:t>
            </a:r>
            <a:r>
              <a:rPr b="0" lang="zh-TW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B) Western blot analysis of EZH2 expression in PLC5 cells following ectopic expression of miR-26a. β-actin was used as loading control. Signal density was quantified by Glyko BandScan software and defined as the ratio of EZH2 to β-actin. These data suggested that miR-26a post-transcriptionally suppressed EZH2 expression in HCC cells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Box 13"/>
          <p:cNvSpPr/>
          <p:nvPr/>
        </p:nvSpPr>
        <p:spPr>
          <a:xfrm>
            <a:off x="2520" y="0"/>
            <a:ext cx="1169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Figure S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Box 14"/>
          <p:cNvSpPr/>
          <p:nvPr/>
        </p:nvSpPr>
        <p:spPr>
          <a:xfrm>
            <a:off x="810720" y="635040"/>
            <a:ext cx="333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Box 15"/>
          <p:cNvSpPr/>
          <p:nvPr/>
        </p:nvSpPr>
        <p:spPr>
          <a:xfrm>
            <a:off x="3201480" y="639720"/>
            <a:ext cx="333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02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6-08T02:43:30Z</dcterms:created>
  <dc:creator>Alfred Cheng</dc:creator>
  <dc:description/>
  <dc:language>en-US</dc:language>
  <cp:lastModifiedBy>Alfred Cheng</cp:lastModifiedBy>
  <dcterms:modified xsi:type="dcterms:W3CDTF">2011-07-16T09:10:53Z</dcterms:modified>
  <cp:revision>18</cp:revision>
  <dc:subject/>
  <dc:title>Slide 1</dc:title>
</cp:coreProperties>
</file>